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>
        <p:scale>
          <a:sx n="182" d="100"/>
          <a:sy n="182" d="100"/>
        </p:scale>
        <p:origin x="1456" y="-1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600CE-5411-DC42-948A-FBAD085CE322}" type="datetimeFigureOut">
              <a:rPr lang="en-US" smtClean="0"/>
              <a:t>5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6A494-56E2-9642-851C-D1ED5B75C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8167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600CE-5411-DC42-948A-FBAD085CE322}" type="datetimeFigureOut">
              <a:rPr lang="en-US" smtClean="0"/>
              <a:t>5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6A494-56E2-9642-851C-D1ED5B75C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952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600CE-5411-DC42-948A-FBAD085CE322}" type="datetimeFigureOut">
              <a:rPr lang="en-US" smtClean="0"/>
              <a:t>5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6A494-56E2-9642-851C-D1ED5B75C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280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600CE-5411-DC42-948A-FBAD085CE322}" type="datetimeFigureOut">
              <a:rPr lang="en-US" smtClean="0"/>
              <a:t>5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6A494-56E2-9642-851C-D1ED5B75C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02732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600CE-5411-DC42-948A-FBAD085CE322}" type="datetimeFigureOut">
              <a:rPr lang="en-US" smtClean="0"/>
              <a:t>5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6A494-56E2-9642-851C-D1ED5B75C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4789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600CE-5411-DC42-948A-FBAD085CE322}" type="datetimeFigureOut">
              <a:rPr lang="en-US" smtClean="0"/>
              <a:t>5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6A494-56E2-9642-851C-D1ED5B75C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0415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600CE-5411-DC42-948A-FBAD085CE322}" type="datetimeFigureOut">
              <a:rPr lang="en-US" smtClean="0"/>
              <a:t>5/12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6A494-56E2-9642-851C-D1ED5B75C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9452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600CE-5411-DC42-948A-FBAD085CE322}" type="datetimeFigureOut">
              <a:rPr lang="en-US" smtClean="0"/>
              <a:t>5/12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6A494-56E2-9642-851C-D1ED5B75C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9449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600CE-5411-DC42-948A-FBAD085CE322}" type="datetimeFigureOut">
              <a:rPr lang="en-US" smtClean="0"/>
              <a:t>5/12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6A494-56E2-9642-851C-D1ED5B75C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2533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600CE-5411-DC42-948A-FBAD085CE322}" type="datetimeFigureOut">
              <a:rPr lang="en-US" smtClean="0"/>
              <a:t>5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6A494-56E2-9642-851C-D1ED5B75C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8223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0600CE-5411-DC42-948A-FBAD085CE322}" type="datetimeFigureOut">
              <a:rPr lang="en-US" smtClean="0"/>
              <a:t>5/12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46A494-56E2-9642-851C-D1ED5B75C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954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0600CE-5411-DC42-948A-FBAD085CE322}" type="datetimeFigureOut">
              <a:rPr lang="en-US" smtClean="0"/>
              <a:t>5/12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46A494-56E2-9642-851C-D1ED5B75C3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01392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Picture 26">
            <a:extLst>
              <a:ext uri="{FF2B5EF4-FFF2-40B4-BE49-F238E27FC236}">
                <a16:creationId xmlns:a16="http://schemas.microsoft.com/office/drawing/2014/main" id="{635814E4-2763-AECC-FC99-DD2EB114F8F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047"/>
          <a:stretch/>
        </p:blipFill>
        <p:spPr>
          <a:xfrm>
            <a:off x="1055384" y="533400"/>
            <a:ext cx="5423823" cy="2895600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9F9D3983-9E8B-6C2A-1D01-B3C3181BCBF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68" t="49401" b="8131"/>
          <a:stretch/>
        </p:blipFill>
        <p:spPr>
          <a:xfrm>
            <a:off x="623534" y="5381188"/>
            <a:ext cx="4331674" cy="1429624"/>
          </a:xfrm>
          <a:prstGeom prst="rect">
            <a:avLst/>
          </a:prstGeom>
        </p:spPr>
      </p:pic>
      <p:grpSp>
        <p:nvGrpSpPr>
          <p:cNvPr id="34" name="Group 33">
            <a:extLst>
              <a:ext uri="{FF2B5EF4-FFF2-40B4-BE49-F238E27FC236}">
                <a16:creationId xmlns:a16="http://schemas.microsoft.com/office/drawing/2014/main" id="{8792AF52-45C1-DF0A-4757-25ADC7FAF23F}"/>
              </a:ext>
            </a:extLst>
          </p:cNvPr>
          <p:cNvGrpSpPr/>
          <p:nvPr/>
        </p:nvGrpSpPr>
        <p:grpSpPr>
          <a:xfrm>
            <a:off x="1024706" y="4018391"/>
            <a:ext cx="1033345" cy="1469898"/>
            <a:chOff x="2548706" y="5949093"/>
            <a:chExt cx="1033345" cy="1469898"/>
          </a:xfrm>
        </p:grpSpPr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3A41C18A-A13E-78C5-960C-9378F0410687}"/>
                </a:ext>
              </a:extLst>
            </p:cNvPr>
            <p:cNvSpPr txBox="1"/>
            <p:nvPr/>
          </p:nvSpPr>
          <p:spPr>
            <a:xfrm rot="16200000">
              <a:off x="2482021" y="7121474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C8FA7A77-81D4-A6C0-9B28-789F38452C3C}"/>
                </a:ext>
              </a:extLst>
            </p:cNvPr>
            <p:cNvSpPr txBox="1"/>
            <p:nvPr/>
          </p:nvSpPr>
          <p:spPr>
            <a:xfrm rot="16200000">
              <a:off x="2443801" y="6882626"/>
              <a:ext cx="84189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gPHYaKO</a:t>
              </a:r>
              <a:r>
                <a:rPr lang="en-US" sz="9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133D657A-5BE4-19F0-45E6-84B4B28E0A0E}"/>
                </a:ext>
              </a:extLst>
            </p:cNvPr>
            <p:cNvSpPr txBox="1"/>
            <p:nvPr/>
          </p:nvSpPr>
          <p:spPr>
            <a:xfrm rot="16200000">
              <a:off x="3156293" y="6993233"/>
              <a:ext cx="6206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o DNA</a:t>
              </a:r>
            </a:p>
          </p:txBody>
        </p:sp>
        <p:sp>
          <p:nvSpPr>
            <p:cNvPr id="32" name="TextBox 7">
              <a:extLst>
                <a:ext uri="{FF2B5EF4-FFF2-40B4-BE49-F238E27FC236}">
                  <a16:creationId xmlns:a16="http://schemas.microsoft.com/office/drawing/2014/main" id="{D2005148-912B-A775-D80F-FFB15E25145B}"/>
                </a:ext>
              </a:extLst>
            </p:cNvPr>
            <p:cNvSpPr txBox="1"/>
            <p:nvPr/>
          </p:nvSpPr>
          <p:spPr>
            <a:xfrm rot="16200000">
              <a:off x="2330429" y="6568626"/>
              <a:ext cx="14698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gPHYaKO</a:t>
              </a:r>
              <a:r>
                <a:rPr lang="en-US" sz="9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:PHYa</a:t>
              </a:r>
              <a:r>
                <a:rPr lang="en-US" sz="9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PHYa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7">
              <a:extLst>
                <a:ext uri="{FF2B5EF4-FFF2-40B4-BE49-F238E27FC236}">
                  <a16:creationId xmlns:a16="http://schemas.microsoft.com/office/drawing/2014/main" id="{D5641037-FE28-64D3-96BF-8EDC8A7F62D7}"/>
                </a:ext>
              </a:extLst>
            </p:cNvPr>
            <p:cNvSpPr txBox="1"/>
            <p:nvPr/>
          </p:nvSpPr>
          <p:spPr>
            <a:xfrm rot="16200000">
              <a:off x="2531057" y="6568626"/>
              <a:ext cx="14698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gPHYaKO</a:t>
              </a:r>
              <a:r>
                <a:rPr lang="en-US" sz="9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:PHYa</a:t>
              </a:r>
              <a:r>
                <a:rPr lang="en-US" sz="9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TUB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5" name="Group 34">
            <a:extLst>
              <a:ext uri="{FF2B5EF4-FFF2-40B4-BE49-F238E27FC236}">
                <a16:creationId xmlns:a16="http://schemas.microsoft.com/office/drawing/2014/main" id="{564442EE-C2A0-B32C-4D7C-B998890CC8AE}"/>
              </a:ext>
            </a:extLst>
          </p:cNvPr>
          <p:cNvGrpSpPr/>
          <p:nvPr/>
        </p:nvGrpSpPr>
        <p:grpSpPr>
          <a:xfrm>
            <a:off x="2353836" y="4018391"/>
            <a:ext cx="1033345" cy="1469898"/>
            <a:chOff x="2548706" y="5949093"/>
            <a:chExt cx="1033345" cy="1469898"/>
          </a:xfrm>
        </p:grpSpPr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3AFE598-1E17-0E97-24BA-5B1FFA5874B2}"/>
                </a:ext>
              </a:extLst>
            </p:cNvPr>
            <p:cNvSpPr txBox="1"/>
            <p:nvPr/>
          </p:nvSpPr>
          <p:spPr>
            <a:xfrm rot="16200000">
              <a:off x="2482021" y="7121474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EB406FFF-B986-DD51-2760-485ADAEED819}"/>
                </a:ext>
              </a:extLst>
            </p:cNvPr>
            <p:cNvSpPr txBox="1"/>
            <p:nvPr/>
          </p:nvSpPr>
          <p:spPr>
            <a:xfrm rot="16200000">
              <a:off x="2443801" y="6882626"/>
              <a:ext cx="84189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gPHYaKO</a:t>
              </a:r>
              <a:r>
                <a:rPr lang="en-US" sz="9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D5D74F43-06DA-782D-3E87-B221489F55BA}"/>
                </a:ext>
              </a:extLst>
            </p:cNvPr>
            <p:cNvSpPr txBox="1"/>
            <p:nvPr/>
          </p:nvSpPr>
          <p:spPr>
            <a:xfrm rot="16200000">
              <a:off x="3156293" y="6993233"/>
              <a:ext cx="6206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o DNA</a:t>
              </a:r>
            </a:p>
          </p:txBody>
        </p:sp>
        <p:sp>
          <p:nvSpPr>
            <p:cNvPr id="39" name="TextBox 7">
              <a:extLst>
                <a:ext uri="{FF2B5EF4-FFF2-40B4-BE49-F238E27FC236}">
                  <a16:creationId xmlns:a16="http://schemas.microsoft.com/office/drawing/2014/main" id="{F4A885F2-F47A-B335-7E6B-DF400085D918}"/>
                </a:ext>
              </a:extLst>
            </p:cNvPr>
            <p:cNvSpPr txBox="1"/>
            <p:nvPr/>
          </p:nvSpPr>
          <p:spPr>
            <a:xfrm rot="16200000">
              <a:off x="2330429" y="6568626"/>
              <a:ext cx="14698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gPHYaKO</a:t>
              </a:r>
              <a:r>
                <a:rPr lang="en-US" sz="9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:PHYa</a:t>
              </a:r>
              <a:r>
                <a:rPr lang="en-US" sz="9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PHYa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7">
              <a:extLst>
                <a:ext uri="{FF2B5EF4-FFF2-40B4-BE49-F238E27FC236}">
                  <a16:creationId xmlns:a16="http://schemas.microsoft.com/office/drawing/2014/main" id="{38191927-360D-B398-C7DF-D644AE7DC330}"/>
                </a:ext>
              </a:extLst>
            </p:cNvPr>
            <p:cNvSpPr txBox="1"/>
            <p:nvPr/>
          </p:nvSpPr>
          <p:spPr>
            <a:xfrm rot="16200000">
              <a:off x="2531057" y="6568626"/>
              <a:ext cx="14698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gPHYaKO</a:t>
              </a:r>
              <a:r>
                <a:rPr lang="en-US" sz="9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:PHYa</a:t>
              </a:r>
              <a:r>
                <a:rPr lang="en-US" sz="9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TUB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1" name="Group 40">
            <a:extLst>
              <a:ext uri="{FF2B5EF4-FFF2-40B4-BE49-F238E27FC236}">
                <a16:creationId xmlns:a16="http://schemas.microsoft.com/office/drawing/2014/main" id="{84B349CB-9E46-501C-87C0-84AF00C2740C}"/>
              </a:ext>
            </a:extLst>
          </p:cNvPr>
          <p:cNvGrpSpPr/>
          <p:nvPr/>
        </p:nvGrpSpPr>
        <p:grpSpPr>
          <a:xfrm>
            <a:off x="3682965" y="4018391"/>
            <a:ext cx="1033345" cy="1469898"/>
            <a:chOff x="2548706" y="5949093"/>
            <a:chExt cx="1033345" cy="1469898"/>
          </a:xfrm>
        </p:grpSpPr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129F85A4-D337-C67F-BBF5-AF9A105B94BA}"/>
                </a:ext>
              </a:extLst>
            </p:cNvPr>
            <p:cNvSpPr txBox="1"/>
            <p:nvPr/>
          </p:nvSpPr>
          <p:spPr>
            <a:xfrm rot="16200000">
              <a:off x="2482021" y="7121474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2A4FD51D-A836-665C-BBD4-61ABC8A4F1D0}"/>
                </a:ext>
              </a:extLst>
            </p:cNvPr>
            <p:cNvSpPr txBox="1"/>
            <p:nvPr/>
          </p:nvSpPr>
          <p:spPr>
            <a:xfrm rot="16200000">
              <a:off x="2443801" y="6882626"/>
              <a:ext cx="841897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TgPHYaKO</a:t>
              </a:r>
              <a:r>
                <a:rPr lang="en-US" sz="9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657E673B-7B1B-7532-D802-FA4C15B75883}"/>
                </a:ext>
              </a:extLst>
            </p:cNvPr>
            <p:cNvSpPr txBox="1"/>
            <p:nvPr/>
          </p:nvSpPr>
          <p:spPr>
            <a:xfrm rot="16200000">
              <a:off x="3156293" y="6993233"/>
              <a:ext cx="62068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No DNA</a:t>
              </a:r>
            </a:p>
          </p:txBody>
        </p:sp>
        <p:sp>
          <p:nvSpPr>
            <p:cNvPr id="45" name="TextBox 7">
              <a:extLst>
                <a:ext uri="{FF2B5EF4-FFF2-40B4-BE49-F238E27FC236}">
                  <a16:creationId xmlns:a16="http://schemas.microsoft.com/office/drawing/2014/main" id="{3744B7BC-399A-8AC2-865B-764A01514284}"/>
                </a:ext>
              </a:extLst>
            </p:cNvPr>
            <p:cNvSpPr txBox="1"/>
            <p:nvPr/>
          </p:nvSpPr>
          <p:spPr>
            <a:xfrm rot="16200000">
              <a:off x="2330429" y="6568626"/>
              <a:ext cx="14698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gPHYaKO</a:t>
              </a:r>
              <a:r>
                <a:rPr lang="en-US" sz="9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:PHYa</a:t>
              </a:r>
              <a:r>
                <a:rPr lang="en-US" sz="9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PHYa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fr-FR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7">
              <a:extLst>
                <a:ext uri="{FF2B5EF4-FFF2-40B4-BE49-F238E27FC236}">
                  <a16:creationId xmlns:a16="http://schemas.microsoft.com/office/drawing/2014/main" id="{F88E3AC6-8EE1-A90A-27AC-8FD56FE8A594}"/>
                </a:ext>
              </a:extLst>
            </p:cNvPr>
            <p:cNvSpPr txBox="1"/>
            <p:nvPr/>
          </p:nvSpPr>
          <p:spPr>
            <a:xfrm rot="16200000">
              <a:off x="2531057" y="6568626"/>
              <a:ext cx="14698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gPHYaKO</a:t>
              </a:r>
              <a:r>
                <a:rPr lang="en-US" sz="9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II</a:t>
              </a:r>
              <a:r>
                <a:rPr lang="en-US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:PHYa</a:t>
              </a:r>
              <a:r>
                <a:rPr lang="en-US" sz="900" b="1" baseline="30000" dirty="0" err="1">
                  <a:latin typeface="Arial" panose="020B0604020202020204" pitchFamily="34" charset="0"/>
                  <a:cs typeface="Arial" panose="020B0604020202020204" pitchFamily="34" charset="0"/>
                </a:rPr>
                <a:t>TUB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en-US" sz="9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endParaRPr>
            </a:p>
          </p:txBody>
        </p:sp>
      </p:grpSp>
      <p:sp>
        <p:nvSpPr>
          <p:cNvPr id="47" name="TextBox 46">
            <a:extLst>
              <a:ext uri="{FF2B5EF4-FFF2-40B4-BE49-F238E27FC236}">
                <a16:creationId xmlns:a16="http://schemas.microsoft.com/office/drawing/2014/main" id="{7454FA3F-A237-1052-B342-7B6C3B7D7E0D}"/>
              </a:ext>
            </a:extLst>
          </p:cNvPr>
          <p:cNvSpPr txBox="1"/>
          <p:nvPr/>
        </p:nvSpPr>
        <p:spPr>
          <a:xfrm>
            <a:off x="1307309" y="685461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R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062F483-9B60-37E4-CE23-343A2BEA0E53}"/>
              </a:ext>
            </a:extLst>
          </p:cNvPr>
          <p:cNvSpPr txBox="1"/>
          <p:nvPr/>
        </p:nvSpPr>
        <p:spPr>
          <a:xfrm>
            <a:off x="2610853" y="6854612"/>
            <a:ext cx="5943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R2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9BA91DC-25EC-5BCC-B088-A5EFFE7C4629}"/>
              </a:ext>
            </a:extLst>
          </p:cNvPr>
          <p:cNvSpPr txBox="1"/>
          <p:nvPr/>
        </p:nvSpPr>
        <p:spPr>
          <a:xfrm>
            <a:off x="3920882" y="6854612"/>
            <a:ext cx="5934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CR3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AF20AE3C-B9C4-EDF3-26A3-A4B53ED92628}"/>
              </a:ext>
            </a:extLst>
          </p:cNvPr>
          <p:cNvCxnSpPr>
            <a:cxnSpLocks/>
          </p:cNvCxnSpPr>
          <p:nvPr/>
        </p:nvCxnSpPr>
        <p:spPr>
          <a:xfrm>
            <a:off x="1055385" y="6857151"/>
            <a:ext cx="10972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AD7CDD29-E684-760A-D1E0-1878A11CF53E}"/>
              </a:ext>
            </a:extLst>
          </p:cNvPr>
          <p:cNvCxnSpPr>
            <a:cxnSpLocks/>
          </p:cNvCxnSpPr>
          <p:nvPr/>
        </p:nvCxnSpPr>
        <p:spPr>
          <a:xfrm>
            <a:off x="2359393" y="6857151"/>
            <a:ext cx="10972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8B89FE0B-7EB7-4288-FDF0-0FB874A575E9}"/>
              </a:ext>
            </a:extLst>
          </p:cNvPr>
          <p:cNvCxnSpPr>
            <a:cxnSpLocks/>
          </p:cNvCxnSpPr>
          <p:nvPr/>
        </p:nvCxnSpPr>
        <p:spPr>
          <a:xfrm>
            <a:off x="3668958" y="6857151"/>
            <a:ext cx="109728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7">
            <a:extLst>
              <a:ext uri="{FF2B5EF4-FFF2-40B4-BE49-F238E27FC236}">
                <a16:creationId xmlns:a16="http://schemas.microsoft.com/office/drawing/2014/main" id="{D264FFB0-AA11-F41F-226D-3D1EC8D572D8}"/>
              </a:ext>
            </a:extLst>
          </p:cNvPr>
          <p:cNvSpPr txBox="1"/>
          <p:nvPr/>
        </p:nvSpPr>
        <p:spPr>
          <a:xfrm>
            <a:off x="840602" y="266350"/>
            <a:ext cx="3682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8" name="TextBox 7">
            <a:extLst>
              <a:ext uri="{FF2B5EF4-FFF2-40B4-BE49-F238E27FC236}">
                <a16:creationId xmlns:a16="http://schemas.microsoft.com/office/drawing/2014/main" id="{380D1F27-653B-0A83-A147-6510E507911C}"/>
              </a:ext>
            </a:extLst>
          </p:cNvPr>
          <p:cNvSpPr txBox="1"/>
          <p:nvPr/>
        </p:nvSpPr>
        <p:spPr>
          <a:xfrm>
            <a:off x="840602" y="3808585"/>
            <a:ext cx="3682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Box 7">
            <a:extLst>
              <a:ext uri="{FF2B5EF4-FFF2-40B4-BE49-F238E27FC236}">
                <a16:creationId xmlns:a16="http://schemas.microsoft.com/office/drawing/2014/main" id="{D6ACF814-6053-6999-0026-1483F538035A}"/>
              </a:ext>
            </a:extLst>
          </p:cNvPr>
          <p:cNvSpPr txBox="1"/>
          <p:nvPr/>
        </p:nvSpPr>
        <p:spPr>
          <a:xfrm>
            <a:off x="5009310" y="2487552"/>
            <a:ext cx="146989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TgPHYaKO</a:t>
            </a:r>
            <a:r>
              <a:rPr lang="en-US" sz="900" b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:PHYa</a:t>
            </a:r>
            <a:r>
              <a:rPr lang="en-US" sz="900" b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PHYa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9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3" name="TextBox 7">
            <a:extLst>
              <a:ext uri="{FF2B5EF4-FFF2-40B4-BE49-F238E27FC236}">
                <a16:creationId xmlns:a16="http://schemas.microsoft.com/office/drawing/2014/main" id="{9D875F3A-2AA0-82AF-2238-89E2C6E921DC}"/>
              </a:ext>
            </a:extLst>
          </p:cNvPr>
          <p:cNvSpPr txBox="1"/>
          <p:nvPr/>
        </p:nvSpPr>
        <p:spPr>
          <a:xfrm>
            <a:off x="5017596" y="2946552"/>
            <a:ext cx="146989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TgPHYaKO</a:t>
            </a:r>
            <a:r>
              <a:rPr lang="en-US" sz="900" b="1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:PHYa</a:t>
            </a:r>
            <a:r>
              <a:rPr lang="en-US" sz="900" b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TUB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9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38913374-C241-3FF3-CD60-D26F53ECADD6}"/>
              </a:ext>
            </a:extLst>
          </p:cNvPr>
          <p:cNvCxnSpPr/>
          <p:nvPr/>
        </p:nvCxnSpPr>
        <p:spPr>
          <a:xfrm>
            <a:off x="437392" y="1695236"/>
            <a:ext cx="81814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7">
            <a:extLst>
              <a:ext uri="{FF2B5EF4-FFF2-40B4-BE49-F238E27FC236}">
                <a16:creationId xmlns:a16="http://schemas.microsoft.com/office/drawing/2014/main" id="{8F43FDB3-6D6B-5159-47C8-E73EF81CAED4}"/>
              </a:ext>
            </a:extLst>
          </p:cNvPr>
          <p:cNvSpPr txBox="1"/>
          <p:nvPr/>
        </p:nvSpPr>
        <p:spPr>
          <a:xfrm>
            <a:off x="520616" y="1702651"/>
            <a:ext cx="619506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1000 bp</a:t>
            </a:r>
            <a:endParaRPr lang="en-US" sz="9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7" name="TextBox 7">
            <a:extLst>
              <a:ext uri="{FF2B5EF4-FFF2-40B4-BE49-F238E27FC236}">
                <a16:creationId xmlns:a16="http://schemas.microsoft.com/office/drawing/2014/main" id="{4E831329-0716-649B-2793-91C7A93EF35F}"/>
              </a:ext>
            </a:extLst>
          </p:cNvPr>
          <p:cNvSpPr txBox="1"/>
          <p:nvPr/>
        </p:nvSpPr>
        <p:spPr>
          <a:xfrm>
            <a:off x="5187395" y="1464404"/>
            <a:ext cx="146989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HYa</a:t>
            </a:r>
            <a:r>
              <a:rPr lang="en-US" sz="900" b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PHYa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9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2C72F33-9D1E-58B0-CEAD-CB89A0CE0DB8}"/>
              </a:ext>
            </a:extLst>
          </p:cNvPr>
          <p:cNvSpPr txBox="1"/>
          <p:nvPr/>
        </p:nvSpPr>
        <p:spPr>
          <a:xfrm>
            <a:off x="5190543" y="1681320"/>
            <a:ext cx="1469897" cy="2308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PHYa</a:t>
            </a:r>
            <a:r>
              <a:rPr lang="en-US" sz="900" b="1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TUB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9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6D26A567-46E0-902A-B604-6D2C81CD240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4194" t="41013" r="58467" b="55041"/>
          <a:stretch/>
        </p:blipFill>
        <p:spPr>
          <a:xfrm>
            <a:off x="2841625" y="1511300"/>
            <a:ext cx="406400" cy="1143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8CE7BDCD-6789-E6D5-80FB-953741B9AE0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4194" t="41013" r="58467" b="55041"/>
          <a:stretch/>
        </p:blipFill>
        <p:spPr>
          <a:xfrm>
            <a:off x="4627866" y="1511300"/>
            <a:ext cx="406400" cy="114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325326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69</TotalTime>
  <Words>45</Words>
  <Application>Microsoft Macintosh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ra Blader</dc:creator>
  <cp:lastModifiedBy>Ira Blader</cp:lastModifiedBy>
  <cp:revision>4</cp:revision>
  <dcterms:created xsi:type="dcterms:W3CDTF">2023-03-30T11:42:20Z</dcterms:created>
  <dcterms:modified xsi:type="dcterms:W3CDTF">2023-05-12T09:53:01Z</dcterms:modified>
</cp:coreProperties>
</file>